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4110D2D-9F43-F24B-B44D-9D28E6A6CCE4}">
          <p14:sldIdLst/>
        </p14:section>
        <p14:section name="Supplementary Figures" id="{66E14E47-7582-AE49-BDB9-E67D19B9D52B}">
          <p14:sldIdLst>
            <p14:sldId id="270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2CF71A"/>
    <a:srgbClr val="0096FF"/>
    <a:srgbClr val="00FDFF"/>
    <a:srgbClr val="00FF00"/>
    <a:srgbClr val="95AEFF"/>
    <a:srgbClr val="50C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-3084" y="-12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9EC868-A74C-2243-AD15-BB00385026E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5D3F5-AADD-464C-822A-DFE3055581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92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806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84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961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56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117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492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564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215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555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93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90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303889-F2ED-934A-A40A-F50FEF14F349}" type="datetimeFigureOut">
              <a:rPr lang="en-US" smtClean="0"/>
              <a:t>9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A28E85-9F7D-EE4C-83D7-DAEDC93450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998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1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microsoft.com/office/2007/relationships/hdphoto" Target="../media/hdphoto1.wdp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1EFB8160-E5E3-8146-8FB2-DCDE8F68E2E2}"/>
              </a:ext>
            </a:extLst>
          </p:cNvPr>
          <p:cNvGrpSpPr/>
          <p:nvPr/>
        </p:nvGrpSpPr>
        <p:grpSpPr>
          <a:xfrm>
            <a:off x="321634" y="835867"/>
            <a:ext cx="6218543" cy="4094531"/>
            <a:chOff x="535946" y="1793130"/>
            <a:chExt cx="6218543" cy="4094531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7157EBF9-0560-5149-8DE8-8D11989446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7823" r="36716"/>
            <a:stretch/>
          </p:blipFill>
          <p:spPr>
            <a:xfrm>
              <a:off x="2249334" y="2114742"/>
              <a:ext cx="1394148" cy="102337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ECA509AB-6B93-C744-B528-FF918EE04A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37823" r="36716"/>
            <a:stretch/>
          </p:blipFill>
          <p:spPr>
            <a:xfrm>
              <a:off x="806886" y="2114742"/>
              <a:ext cx="1394148" cy="1023376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753DE5A7-BA3D-AE40-BF8A-A366EA7B0E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24174" r="36534" b="13471"/>
            <a:stretch/>
          </p:blipFill>
          <p:spPr>
            <a:xfrm>
              <a:off x="3799052" y="2119052"/>
              <a:ext cx="1394148" cy="1023376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9504F3C7-1CB1-3B47-A0E9-722FDE8966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24106" r="36716" b="13718"/>
            <a:stretch/>
          </p:blipFill>
          <p:spPr>
            <a:xfrm>
              <a:off x="5241500" y="2119052"/>
              <a:ext cx="1394148" cy="1023376"/>
            </a:xfrm>
            <a:prstGeom prst="rect">
              <a:avLst/>
            </a:prstGeom>
          </p:spPr>
        </p:pic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xmlns="" id="{5765806C-9124-C947-9717-F740578578FB}"/>
                </a:ext>
              </a:extLst>
            </p:cNvPr>
            <p:cNvSpPr/>
            <p:nvPr/>
          </p:nvSpPr>
          <p:spPr>
            <a:xfrm>
              <a:off x="806886" y="1884930"/>
              <a:ext cx="1394148" cy="20323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B9A57CF3-55D8-CA4D-9ACB-7F22DAADE3DE}"/>
                </a:ext>
              </a:extLst>
            </p:cNvPr>
            <p:cNvSpPr txBox="1"/>
            <p:nvPr/>
          </p:nvSpPr>
          <p:spPr>
            <a:xfrm>
              <a:off x="1160518" y="1883910"/>
              <a:ext cx="6976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solidFill>
                    <a:srgbClr val="FF0000"/>
                  </a:solidFill>
                </a:rPr>
                <a:t>H3K27me3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xmlns="" id="{234BD1C3-6B85-2841-8298-CF69F823BF50}"/>
                </a:ext>
              </a:extLst>
            </p:cNvPr>
            <p:cNvSpPr/>
            <p:nvPr/>
          </p:nvSpPr>
          <p:spPr>
            <a:xfrm>
              <a:off x="2254968" y="1884930"/>
              <a:ext cx="1394148" cy="20323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68B61DB2-CC5E-C940-9F05-A84F518AC7B2}"/>
                </a:ext>
              </a:extLst>
            </p:cNvPr>
            <p:cNvSpPr txBox="1"/>
            <p:nvPr/>
          </p:nvSpPr>
          <p:spPr>
            <a:xfrm>
              <a:off x="2741063" y="1871130"/>
              <a:ext cx="4106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solidFill>
                    <a:srgbClr val="0432FF"/>
                  </a:solidFill>
                </a:rPr>
                <a:t>DAPI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7B5DC95C-F485-3D4B-A85E-AF07F7F9ECF6}"/>
                </a:ext>
              </a:extLst>
            </p:cNvPr>
            <p:cNvSpPr txBox="1"/>
            <p:nvPr/>
          </p:nvSpPr>
          <p:spPr>
            <a:xfrm>
              <a:off x="763695" y="2080027"/>
              <a:ext cx="57259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solidFill>
                    <a:schemeClr val="bg1"/>
                  </a:solidFill>
                </a:rPr>
                <a:t>Male FB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BE02F3E4-132D-5E49-A8CE-BA875BC5EC46}"/>
                </a:ext>
              </a:extLst>
            </p:cNvPr>
            <p:cNvSpPr txBox="1"/>
            <p:nvPr/>
          </p:nvSpPr>
          <p:spPr>
            <a:xfrm>
              <a:off x="3750752" y="2084337"/>
              <a:ext cx="6767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solidFill>
                    <a:schemeClr val="bg1"/>
                  </a:solidFill>
                </a:rPr>
                <a:t>Female FB</a:t>
              </a:r>
            </a:p>
          </p:txBody>
        </p:sp>
        <p:cxnSp>
          <p:nvCxnSpPr>
            <p:cNvPr id="28" name="Straight Connector 29">
              <a:extLst>
                <a:ext uri="{FF2B5EF4-FFF2-40B4-BE49-F238E27FC236}">
                  <a16:creationId xmlns:a16="http://schemas.microsoft.com/office/drawing/2014/main" xmlns="" id="{1F576974-A96B-6145-935E-D19CE73400E9}"/>
                </a:ext>
              </a:extLst>
            </p:cNvPr>
            <p:cNvCxnSpPr>
              <a:cxnSpLocks/>
            </p:cNvCxnSpPr>
            <p:nvPr/>
          </p:nvCxnSpPr>
          <p:spPr>
            <a:xfrm>
              <a:off x="6327072" y="3093778"/>
              <a:ext cx="269321" cy="0"/>
            </a:xfrm>
            <a:prstGeom prst="line">
              <a:avLst/>
            </a:prstGeom>
            <a:ln w="19050" cmpd="sng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feld 81">
              <a:extLst>
                <a:ext uri="{FF2B5EF4-FFF2-40B4-BE49-F238E27FC236}">
                  <a16:creationId xmlns:a16="http://schemas.microsoft.com/office/drawing/2014/main" xmlns="" id="{A24EC9A0-5E49-DA40-8704-6EC0FDE73314}"/>
                </a:ext>
              </a:extLst>
            </p:cNvPr>
            <p:cNvSpPr txBox="1"/>
            <p:nvPr/>
          </p:nvSpPr>
          <p:spPr>
            <a:xfrm>
              <a:off x="6268474" y="2949054"/>
              <a:ext cx="4328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solidFill>
                    <a:schemeClr val="bg1"/>
                  </a:solidFill>
                  <a:latin typeface="+mj-lt"/>
                  <a:cs typeface="Arial"/>
                </a:rPr>
                <a:t>25 μm</a:t>
              </a:r>
            </a:p>
          </p:txBody>
        </p:sp>
        <p:sp>
          <p:nvSpPr>
            <p:cNvPr id="30" name="Triangle 29">
              <a:extLst>
                <a:ext uri="{FF2B5EF4-FFF2-40B4-BE49-F238E27FC236}">
                  <a16:creationId xmlns:a16="http://schemas.microsoft.com/office/drawing/2014/main" xmlns="" id="{AF36DD8E-16D9-4E41-AAFC-0F5E46F5E55C}"/>
                </a:ext>
              </a:extLst>
            </p:cNvPr>
            <p:cNvSpPr/>
            <p:nvPr/>
          </p:nvSpPr>
          <p:spPr>
            <a:xfrm rot="3249987">
              <a:off x="3974465" y="2354460"/>
              <a:ext cx="70637" cy="95934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Triangle 30">
              <a:extLst>
                <a:ext uri="{FF2B5EF4-FFF2-40B4-BE49-F238E27FC236}">
                  <a16:creationId xmlns:a16="http://schemas.microsoft.com/office/drawing/2014/main" xmlns="" id="{792F3B03-C5D7-5546-940F-76D585CD2F9E}"/>
                </a:ext>
              </a:extLst>
            </p:cNvPr>
            <p:cNvSpPr/>
            <p:nvPr/>
          </p:nvSpPr>
          <p:spPr>
            <a:xfrm rot="3249987">
              <a:off x="4320288" y="2354388"/>
              <a:ext cx="70637" cy="95934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Triangle 31">
              <a:extLst>
                <a:ext uri="{FF2B5EF4-FFF2-40B4-BE49-F238E27FC236}">
                  <a16:creationId xmlns:a16="http://schemas.microsoft.com/office/drawing/2014/main" xmlns="" id="{5E1B7052-2C72-9B4F-A165-F33689CDE6C2}"/>
                </a:ext>
              </a:extLst>
            </p:cNvPr>
            <p:cNvSpPr/>
            <p:nvPr/>
          </p:nvSpPr>
          <p:spPr>
            <a:xfrm rot="18754213">
              <a:off x="4503058" y="2582772"/>
              <a:ext cx="70637" cy="95934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Triangle 32">
              <a:extLst>
                <a:ext uri="{FF2B5EF4-FFF2-40B4-BE49-F238E27FC236}">
                  <a16:creationId xmlns:a16="http://schemas.microsoft.com/office/drawing/2014/main" xmlns="" id="{1362F3CE-9B4A-9947-88A4-4DD0FBA76042}"/>
                </a:ext>
              </a:extLst>
            </p:cNvPr>
            <p:cNvSpPr/>
            <p:nvPr/>
          </p:nvSpPr>
          <p:spPr>
            <a:xfrm rot="18765244">
              <a:off x="4443390" y="2949251"/>
              <a:ext cx="70637" cy="95934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Triangle 33">
              <a:extLst>
                <a:ext uri="{FF2B5EF4-FFF2-40B4-BE49-F238E27FC236}">
                  <a16:creationId xmlns:a16="http://schemas.microsoft.com/office/drawing/2014/main" xmlns="" id="{952474D3-DBD5-7344-859F-B9E90BD3FBA3}"/>
                </a:ext>
              </a:extLst>
            </p:cNvPr>
            <p:cNvSpPr/>
            <p:nvPr/>
          </p:nvSpPr>
          <p:spPr>
            <a:xfrm rot="18585264">
              <a:off x="4887652" y="2760041"/>
              <a:ext cx="70637" cy="95934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xmlns="" id="{EF124A0D-CFCA-8940-B6EA-2D65E68582DE}"/>
                </a:ext>
              </a:extLst>
            </p:cNvPr>
            <p:cNvSpPr txBox="1"/>
            <p:nvPr/>
          </p:nvSpPr>
          <p:spPr>
            <a:xfrm>
              <a:off x="539048" y="179313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A</a:t>
              </a:r>
            </a:p>
          </p:txBody>
        </p:sp>
        <p:pic>
          <p:nvPicPr>
            <p:cNvPr id="2" name="Picture 1" descr="negCOmouse594.lif - Image002 - C=0.p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15318" y="3520215"/>
              <a:ext cx="1397354" cy="1044000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2218524" y="3277169"/>
              <a:ext cx="1394148" cy="230832"/>
              <a:chOff x="2218524" y="3189779"/>
              <a:chExt cx="1394148" cy="230832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xmlns="" id="{234BD1C3-6B85-2841-8298-CF69F823BF50}"/>
                  </a:ext>
                </a:extLst>
              </p:cNvPr>
              <p:cNvSpPr/>
              <p:nvPr/>
            </p:nvSpPr>
            <p:spPr>
              <a:xfrm>
                <a:off x="2218524" y="3203579"/>
                <a:ext cx="1394148" cy="2032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xmlns="" id="{68B61DB2-CC5E-C940-9F05-A84F518AC7B2}"/>
                  </a:ext>
                </a:extLst>
              </p:cNvPr>
              <p:cNvSpPr txBox="1"/>
              <p:nvPr/>
            </p:nvSpPr>
            <p:spPr>
              <a:xfrm>
                <a:off x="2704619" y="3189779"/>
                <a:ext cx="41069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solidFill>
                      <a:srgbClr val="0432FF"/>
                    </a:solidFill>
                  </a:rPr>
                  <a:t>DAPI</a:t>
                </a:r>
              </a:p>
            </p:txBody>
          </p:sp>
        </p:grpSp>
        <p:pic>
          <p:nvPicPr>
            <p:cNvPr id="3" name="Picture 2" descr="negCOmouse594.lif - Image004 - C=0.pn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7236" y="3520215"/>
              <a:ext cx="1397354" cy="1044000"/>
            </a:xfrm>
            <a:prstGeom prst="rect">
              <a:avLst/>
            </a:prstGeom>
          </p:spPr>
        </p:pic>
        <p:grpSp>
          <p:nvGrpSpPr>
            <p:cNvPr id="4" name="Group 3"/>
            <p:cNvGrpSpPr/>
            <p:nvPr/>
          </p:nvGrpSpPr>
          <p:grpSpPr>
            <a:xfrm>
              <a:off x="770442" y="3283557"/>
              <a:ext cx="1394148" cy="230832"/>
              <a:chOff x="770442" y="3201993"/>
              <a:chExt cx="1394148" cy="230832"/>
            </a:xfrm>
          </p:grpSpPr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xmlns="" id="{234BD1C3-6B85-2841-8298-CF69F823BF50}"/>
                  </a:ext>
                </a:extLst>
              </p:cNvPr>
              <p:cNvSpPr/>
              <p:nvPr/>
            </p:nvSpPr>
            <p:spPr>
              <a:xfrm>
                <a:off x="770442" y="3209193"/>
                <a:ext cx="1394148" cy="2032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xmlns="" id="{68B61DB2-CC5E-C940-9F05-A84F518AC7B2}"/>
                  </a:ext>
                </a:extLst>
              </p:cNvPr>
              <p:cNvSpPr txBox="1"/>
              <p:nvPr/>
            </p:nvSpPr>
            <p:spPr>
              <a:xfrm>
                <a:off x="995936" y="3201993"/>
                <a:ext cx="9028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solidFill>
                      <a:srgbClr val="FF0000"/>
                    </a:solidFill>
                  </a:rPr>
                  <a:t>G α mouse 594</a:t>
                </a:r>
              </a:p>
            </p:txBody>
          </p:sp>
        </p:grpSp>
        <p:grpSp>
          <p:nvGrpSpPr>
            <p:cNvPr id="41" name="Group 40"/>
            <p:cNvGrpSpPr/>
            <p:nvPr/>
          </p:nvGrpSpPr>
          <p:grpSpPr>
            <a:xfrm>
              <a:off x="2218524" y="4599171"/>
              <a:ext cx="1394148" cy="230832"/>
              <a:chOff x="2218524" y="3189779"/>
              <a:chExt cx="1394148" cy="230832"/>
            </a:xfrm>
          </p:grpSpPr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xmlns="" id="{234BD1C3-6B85-2841-8298-CF69F823BF50}"/>
                  </a:ext>
                </a:extLst>
              </p:cNvPr>
              <p:cNvSpPr/>
              <p:nvPr/>
            </p:nvSpPr>
            <p:spPr>
              <a:xfrm>
                <a:off x="2218524" y="3203579"/>
                <a:ext cx="1394148" cy="2032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xmlns="" id="{68B61DB2-CC5E-C940-9F05-A84F518AC7B2}"/>
                  </a:ext>
                </a:extLst>
              </p:cNvPr>
              <p:cNvSpPr txBox="1"/>
              <p:nvPr/>
            </p:nvSpPr>
            <p:spPr>
              <a:xfrm>
                <a:off x="2704619" y="3189779"/>
                <a:ext cx="41069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solidFill>
                      <a:srgbClr val="0432FF"/>
                    </a:solidFill>
                  </a:rPr>
                  <a:t>DAPI</a:t>
                </a:r>
              </a:p>
            </p:txBody>
          </p:sp>
        </p:grpSp>
        <p:grpSp>
          <p:nvGrpSpPr>
            <p:cNvPr id="44" name="Group 43"/>
            <p:cNvGrpSpPr/>
            <p:nvPr/>
          </p:nvGrpSpPr>
          <p:grpSpPr>
            <a:xfrm>
              <a:off x="770442" y="4605559"/>
              <a:ext cx="1394148" cy="230832"/>
              <a:chOff x="770442" y="3201993"/>
              <a:chExt cx="1394148" cy="230832"/>
            </a:xfrm>
          </p:grpSpPr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xmlns="" id="{234BD1C3-6B85-2841-8298-CF69F823BF50}"/>
                  </a:ext>
                </a:extLst>
              </p:cNvPr>
              <p:cNvSpPr/>
              <p:nvPr/>
            </p:nvSpPr>
            <p:spPr>
              <a:xfrm>
                <a:off x="770442" y="3209193"/>
                <a:ext cx="1394148" cy="2032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xmlns="" id="{68B61DB2-CC5E-C940-9F05-A84F518AC7B2}"/>
                  </a:ext>
                </a:extLst>
              </p:cNvPr>
              <p:cNvSpPr txBox="1"/>
              <p:nvPr/>
            </p:nvSpPr>
            <p:spPr>
              <a:xfrm>
                <a:off x="995936" y="3201993"/>
                <a:ext cx="8929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solidFill>
                      <a:srgbClr val="00B050"/>
                    </a:solidFill>
                  </a:rPr>
                  <a:t>G α mouse 488</a:t>
                </a:r>
              </a:p>
            </p:txBody>
          </p:sp>
        </p:grpSp>
        <p:pic>
          <p:nvPicPr>
            <p:cNvPr id="8" name="Picture 7" descr="negCPmouse488.lif - Image002 - C=0.png"/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06478" y="4842217"/>
              <a:ext cx="1397354" cy="1044000"/>
            </a:xfrm>
            <a:prstGeom prst="rect">
              <a:avLst/>
            </a:prstGeom>
          </p:spPr>
        </p:pic>
        <p:pic>
          <p:nvPicPr>
            <p:cNvPr id="9" name="Picture 8" descr="negCPmouse488dapi.png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0442" y="4843661"/>
              <a:ext cx="1397354" cy="1044000"/>
            </a:xfrm>
            <a:prstGeom prst="rect">
              <a:avLst/>
            </a:prstGeom>
          </p:spPr>
        </p:pic>
        <p:grpSp>
          <p:nvGrpSpPr>
            <p:cNvPr id="47" name="Group 46"/>
            <p:cNvGrpSpPr/>
            <p:nvPr/>
          </p:nvGrpSpPr>
          <p:grpSpPr>
            <a:xfrm>
              <a:off x="5238294" y="3276958"/>
              <a:ext cx="1394148" cy="230832"/>
              <a:chOff x="2218524" y="3189779"/>
              <a:chExt cx="1394148" cy="230832"/>
            </a:xfrm>
          </p:grpSpPr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xmlns="" id="{234BD1C3-6B85-2841-8298-CF69F823BF50}"/>
                  </a:ext>
                </a:extLst>
              </p:cNvPr>
              <p:cNvSpPr/>
              <p:nvPr/>
            </p:nvSpPr>
            <p:spPr>
              <a:xfrm>
                <a:off x="2218524" y="3203579"/>
                <a:ext cx="1394148" cy="2032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xmlns="" id="{68B61DB2-CC5E-C940-9F05-A84F518AC7B2}"/>
                  </a:ext>
                </a:extLst>
              </p:cNvPr>
              <p:cNvSpPr txBox="1"/>
              <p:nvPr/>
            </p:nvSpPr>
            <p:spPr>
              <a:xfrm>
                <a:off x="2704619" y="3189779"/>
                <a:ext cx="41069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solidFill>
                      <a:srgbClr val="0432FF"/>
                    </a:solidFill>
                  </a:rPr>
                  <a:t>DAPI</a:t>
                </a: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3790212" y="3283346"/>
              <a:ext cx="1394148" cy="230832"/>
              <a:chOff x="770442" y="3201993"/>
              <a:chExt cx="1394148" cy="230832"/>
            </a:xfrm>
          </p:grpSpPr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xmlns="" id="{234BD1C3-6B85-2841-8298-CF69F823BF50}"/>
                  </a:ext>
                </a:extLst>
              </p:cNvPr>
              <p:cNvSpPr/>
              <p:nvPr/>
            </p:nvSpPr>
            <p:spPr>
              <a:xfrm>
                <a:off x="770442" y="3209193"/>
                <a:ext cx="1394148" cy="2032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xmlns="" id="{68B61DB2-CC5E-C940-9F05-A84F518AC7B2}"/>
                  </a:ext>
                </a:extLst>
              </p:cNvPr>
              <p:cNvSpPr txBox="1"/>
              <p:nvPr/>
            </p:nvSpPr>
            <p:spPr>
              <a:xfrm>
                <a:off x="995936" y="3201993"/>
                <a:ext cx="8643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solidFill>
                      <a:srgbClr val="FF0000"/>
                    </a:solidFill>
                  </a:rPr>
                  <a:t>G α rabbit 594</a:t>
                </a:r>
              </a:p>
            </p:txBody>
          </p:sp>
        </p:grpSp>
        <p:pic>
          <p:nvPicPr>
            <p:cNvPr id="10" name="Picture 9" descr="negCOrb594.lif - Image002 - C=0.png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5088" y="3520215"/>
              <a:ext cx="1397354" cy="1044000"/>
            </a:xfrm>
            <a:prstGeom prst="rect">
              <a:avLst/>
            </a:prstGeom>
          </p:spPr>
        </p:pic>
        <p:pic>
          <p:nvPicPr>
            <p:cNvPr id="11" name="Picture 10" descr="negCOrb594.lif - Image004 - C=0.png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7006" y="3520215"/>
              <a:ext cx="1397354" cy="1044000"/>
            </a:xfrm>
            <a:prstGeom prst="rect">
              <a:avLst/>
            </a:prstGeom>
          </p:spPr>
        </p:pic>
        <p:grpSp>
          <p:nvGrpSpPr>
            <p:cNvPr id="53" name="Group 52"/>
            <p:cNvGrpSpPr/>
            <p:nvPr/>
          </p:nvGrpSpPr>
          <p:grpSpPr>
            <a:xfrm>
              <a:off x="5235088" y="4593907"/>
              <a:ext cx="1394148" cy="230832"/>
              <a:chOff x="2218524" y="3189779"/>
              <a:chExt cx="1394148" cy="230832"/>
            </a:xfrm>
          </p:grpSpPr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xmlns="" id="{234BD1C3-6B85-2841-8298-CF69F823BF50}"/>
                  </a:ext>
                </a:extLst>
              </p:cNvPr>
              <p:cNvSpPr/>
              <p:nvPr/>
            </p:nvSpPr>
            <p:spPr>
              <a:xfrm>
                <a:off x="2218524" y="3203579"/>
                <a:ext cx="1394148" cy="2032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xmlns="" id="{68B61DB2-CC5E-C940-9F05-A84F518AC7B2}"/>
                  </a:ext>
                </a:extLst>
              </p:cNvPr>
              <p:cNvSpPr txBox="1"/>
              <p:nvPr/>
            </p:nvSpPr>
            <p:spPr>
              <a:xfrm>
                <a:off x="2704619" y="3189779"/>
                <a:ext cx="41069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solidFill>
                      <a:srgbClr val="0432FF"/>
                    </a:solidFill>
                  </a:rPr>
                  <a:t>DAPI</a:t>
                </a:r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3787006" y="4600295"/>
              <a:ext cx="1394148" cy="230832"/>
              <a:chOff x="770442" y="3201993"/>
              <a:chExt cx="1394148" cy="230832"/>
            </a:xfrm>
          </p:grpSpPr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xmlns="" id="{234BD1C3-6B85-2841-8298-CF69F823BF50}"/>
                  </a:ext>
                </a:extLst>
              </p:cNvPr>
              <p:cNvSpPr/>
              <p:nvPr/>
            </p:nvSpPr>
            <p:spPr>
              <a:xfrm>
                <a:off x="770442" y="3209193"/>
                <a:ext cx="1394148" cy="20323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xmlns="" id="{68B61DB2-CC5E-C940-9F05-A84F518AC7B2}"/>
                  </a:ext>
                </a:extLst>
              </p:cNvPr>
              <p:cNvSpPr txBox="1"/>
              <p:nvPr/>
            </p:nvSpPr>
            <p:spPr>
              <a:xfrm>
                <a:off x="995936" y="3201993"/>
                <a:ext cx="89299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solidFill>
                      <a:srgbClr val="00B050"/>
                    </a:solidFill>
                  </a:rPr>
                  <a:t>G α mouse 488</a:t>
                </a:r>
              </a:p>
            </p:txBody>
          </p:sp>
        </p:grpSp>
        <p:pic>
          <p:nvPicPr>
            <p:cNvPr id="12" name="Picture 11" descr="negCOrb488.lif - Image007 - C=0.png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7006" y="4843661"/>
              <a:ext cx="1397354" cy="1044000"/>
            </a:xfrm>
            <a:prstGeom prst="rect">
              <a:avLst/>
            </a:prstGeom>
          </p:spPr>
        </p:pic>
        <p:pic>
          <p:nvPicPr>
            <p:cNvPr id="13" name="Picture 12" descr="negCOrb488.lif - Image009 - C=0.png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8294" y="4842217"/>
              <a:ext cx="1397354" cy="1044000"/>
            </a:xfrm>
            <a:prstGeom prst="rect">
              <a:avLst/>
            </a:prstGeom>
          </p:spPr>
        </p:pic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xmlns="" id="{BE02F3E4-132D-5E49-A8CE-BA875BC5EC46}"/>
                </a:ext>
              </a:extLst>
            </p:cNvPr>
            <p:cNvSpPr txBox="1"/>
            <p:nvPr/>
          </p:nvSpPr>
          <p:spPr>
            <a:xfrm>
              <a:off x="713543" y="3476301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solidFill>
                    <a:schemeClr val="bg1"/>
                  </a:solidFill>
                </a:rPr>
                <a:t>iPSC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BE02F3E4-132D-5E49-A8CE-BA875BC5EC46}"/>
                </a:ext>
              </a:extLst>
            </p:cNvPr>
            <p:cNvSpPr txBox="1"/>
            <p:nvPr/>
          </p:nvSpPr>
          <p:spPr>
            <a:xfrm>
              <a:off x="714811" y="4795609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solidFill>
                    <a:schemeClr val="bg1"/>
                  </a:solidFill>
                </a:rPr>
                <a:t>iPSC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BE02F3E4-132D-5E49-A8CE-BA875BC5EC46}"/>
                </a:ext>
              </a:extLst>
            </p:cNvPr>
            <p:cNvSpPr txBox="1"/>
            <p:nvPr/>
          </p:nvSpPr>
          <p:spPr>
            <a:xfrm>
              <a:off x="3734581" y="3479433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solidFill>
                    <a:schemeClr val="bg1"/>
                  </a:solidFill>
                </a:rPr>
                <a:t>iPSC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BE02F3E4-132D-5E49-A8CE-BA875BC5EC46}"/>
                </a:ext>
              </a:extLst>
            </p:cNvPr>
            <p:cNvSpPr txBox="1"/>
            <p:nvPr/>
          </p:nvSpPr>
          <p:spPr>
            <a:xfrm>
              <a:off x="3726137" y="4808705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solidFill>
                    <a:schemeClr val="bg1"/>
                  </a:solidFill>
                </a:rPr>
                <a:t>iPSC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EF124A0D-CFCA-8940-B6EA-2D65E68582DE}"/>
                </a:ext>
              </a:extLst>
            </p:cNvPr>
            <p:cNvSpPr txBox="1"/>
            <p:nvPr/>
          </p:nvSpPr>
          <p:spPr>
            <a:xfrm>
              <a:off x="535946" y="3185346"/>
              <a:ext cx="2824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/>
                <a:t>B</a:t>
              </a:r>
            </a:p>
          </p:txBody>
        </p:sp>
        <p:cxnSp>
          <p:nvCxnSpPr>
            <p:cNvPr id="69" name="Straight Connector 68"/>
            <p:cNvCxnSpPr/>
            <p:nvPr/>
          </p:nvCxnSpPr>
          <p:spPr>
            <a:xfrm>
              <a:off x="6429375" y="5834492"/>
              <a:ext cx="164309" cy="0"/>
            </a:xfrm>
            <a:prstGeom prst="line">
              <a:avLst/>
            </a:prstGeom>
            <a:ln w="19050" cmpd="sng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feld 81">
              <a:extLst>
                <a:ext uri="{FF2B5EF4-FFF2-40B4-BE49-F238E27FC236}">
                  <a16:creationId xmlns:a16="http://schemas.microsoft.com/office/drawing/2014/main" xmlns="" id="{A24EC9A0-5E49-DA40-8704-6EC0FDE73314}"/>
                </a:ext>
              </a:extLst>
            </p:cNvPr>
            <p:cNvSpPr txBox="1"/>
            <p:nvPr/>
          </p:nvSpPr>
          <p:spPr>
            <a:xfrm>
              <a:off x="6321599" y="5676432"/>
              <a:ext cx="4328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solidFill>
                    <a:schemeClr val="bg1"/>
                  </a:solidFill>
                  <a:latin typeface="+mj-lt"/>
                  <a:cs typeface="Arial"/>
                </a:rPr>
                <a:t>50 </a:t>
              </a:r>
              <a:r>
                <a:rPr lang="en-GB" sz="600" dirty="0" err="1">
                  <a:solidFill>
                    <a:schemeClr val="bg1"/>
                  </a:solidFill>
                  <a:latin typeface="+mj-lt"/>
                  <a:cs typeface="Arial"/>
                </a:rPr>
                <a:t>μm</a:t>
              </a:r>
              <a:endParaRPr lang="en-GB" sz="600" dirty="0">
                <a:solidFill>
                  <a:schemeClr val="bg1"/>
                </a:solidFill>
                <a:latin typeface="+mj-lt"/>
                <a:cs typeface="Arial"/>
              </a:endParaRP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xmlns="" id="{0A7E342E-EB6E-8C49-AA81-17DAF33CDC7C}"/>
                </a:ext>
              </a:extLst>
            </p:cNvPr>
            <p:cNvSpPr/>
            <p:nvPr/>
          </p:nvSpPr>
          <p:spPr>
            <a:xfrm>
              <a:off x="3793418" y="1884333"/>
              <a:ext cx="1394148" cy="20323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2A5DE68A-E350-C043-84FB-0FE770D84B55}"/>
                </a:ext>
              </a:extLst>
            </p:cNvPr>
            <p:cNvSpPr txBox="1"/>
            <p:nvPr/>
          </p:nvSpPr>
          <p:spPr>
            <a:xfrm>
              <a:off x="4147050" y="1883313"/>
              <a:ext cx="6976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solidFill>
                    <a:srgbClr val="FF0000"/>
                  </a:solidFill>
                </a:rPr>
                <a:t>H3K27me3</a:t>
              </a: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xmlns="" id="{0A9DE2BF-24F7-2B4A-B143-3E798D6B7621}"/>
                </a:ext>
              </a:extLst>
            </p:cNvPr>
            <p:cNvSpPr/>
            <p:nvPr/>
          </p:nvSpPr>
          <p:spPr>
            <a:xfrm>
              <a:off x="5241500" y="1884333"/>
              <a:ext cx="1394148" cy="20323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3610E426-5F5A-0A40-8549-1F09A78AE1C5}"/>
                </a:ext>
              </a:extLst>
            </p:cNvPr>
            <p:cNvSpPr txBox="1"/>
            <p:nvPr/>
          </p:nvSpPr>
          <p:spPr>
            <a:xfrm>
              <a:off x="5727595" y="1870533"/>
              <a:ext cx="4106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solidFill>
                    <a:srgbClr val="0432FF"/>
                  </a:solidFill>
                </a:rPr>
                <a:t>DAPI</a:t>
              </a: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49F25AC5-6ADC-5140-9401-36056E18BC79}"/>
              </a:ext>
            </a:extLst>
          </p:cNvPr>
          <p:cNvSpPr txBox="1"/>
          <p:nvPr/>
        </p:nvSpPr>
        <p:spPr>
          <a:xfrm>
            <a:off x="212376" y="277270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S3</a:t>
            </a:r>
          </a:p>
        </p:txBody>
      </p:sp>
    </p:spTree>
    <p:extLst>
      <p:ext uri="{BB962C8B-B14F-4D97-AF65-F5344CB8AC3E}">
        <p14:creationId xmlns:p14="http://schemas.microsoft.com/office/powerpoint/2010/main" val="1979212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</TotalTime>
  <Words>41</Words>
  <Application>Microsoft Office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U Amsterd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Hinz</dc:creator>
  <cp:lastModifiedBy>S3G_Apply_Fixed_Case</cp:lastModifiedBy>
  <cp:revision>200</cp:revision>
  <dcterms:created xsi:type="dcterms:W3CDTF">2017-03-30T12:13:45Z</dcterms:created>
  <dcterms:modified xsi:type="dcterms:W3CDTF">2018-09-25T19:22:26Z</dcterms:modified>
</cp:coreProperties>
</file>